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58" r:id="rId3"/>
    <p:sldId id="259" r:id="rId4"/>
    <p:sldId id="260" r:id="rId5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3" d="100"/>
          <a:sy n="103" d="100"/>
        </p:scale>
        <p:origin x="-19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FCF269A-20F7-4469-B682-3C24989FA3C9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E37B34-8D7F-495A-BF09-488E928EC50E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42729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866F5E1-CFD6-46CD-ADD0-ED3A695DC93E}" type="slidenum">
              <a:rPr lang="en-US" smtClean="0"/>
              <a:pPr/>
              <a:t>3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0C643-22A4-4B18-BA36-B7961930ED66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1552-AF95-4572-BF21-A8CC263320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0C643-22A4-4B18-BA36-B7961930ED66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1552-AF95-4572-BF21-A8CC263320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0C643-22A4-4B18-BA36-B7961930ED66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1552-AF95-4572-BF21-A8CC263320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0C643-22A4-4B18-BA36-B7961930ED66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1552-AF95-4572-BF21-A8CC263320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0C643-22A4-4B18-BA36-B7961930ED66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1552-AF95-4572-BF21-A8CC263320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0C643-22A4-4B18-BA36-B7961930ED66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1552-AF95-4572-BF21-A8CC263320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0C643-22A4-4B18-BA36-B7961930ED66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1552-AF95-4572-BF21-A8CC263320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0C643-22A4-4B18-BA36-B7961930ED66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1552-AF95-4572-BF21-A8CC263320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0C643-22A4-4B18-BA36-B7961930ED66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1552-AF95-4572-BF21-A8CC263320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0C643-22A4-4B18-BA36-B7961930ED66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1552-AF95-4572-BF21-A8CC263320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D0C643-22A4-4B18-BA36-B7961930ED66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B1552-AF95-4572-BF21-A8CC2633209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D0C643-22A4-4B18-BA36-B7961930ED66}" type="datetimeFigureOut">
              <a:rPr lang="en-US" smtClean="0"/>
              <a:pPr/>
              <a:t>1/2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B1552-AF95-4572-BF21-A8CC2633209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6705600" y="5486401"/>
            <a:ext cx="2010078" cy="2769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5" tIns="45713" rIns="91425" bIns="45713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914256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ure S1a</a:t>
            </a:r>
            <a:endParaRPr lang="en-US" altLang="ja-JP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314812" y="459616"/>
            <a:ext cx="8524389" cy="4721984"/>
            <a:chOff x="314812" y="459616"/>
            <a:chExt cx="8524389" cy="4721984"/>
          </a:xfrm>
        </p:grpSpPr>
        <p:sp>
          <p:nvSpPr>
            <p:cNvPr id="6" name="TextBox 5"/>
            <p:cNvSpPr txBox="1"/>
            <p:nvPr/>
          </p:nvSpPr>
          <p:spPr>
            <a:xfrm>
              <a:off x="990600" y="459616"/>
              <a:ext cx="1524000" cy="276985"/>
            </a:xfrm>
            <a:prstGeom prst="rect">
              <a:avLst/>
            </a:prstGeom>
            <a:noFill/>
          </p:spPr>
          <p:txBody>
            <a:bodyPr wrap="square" lIns="91425" tIns="45713" rIns="91425" bIns="45713" rtlCol="0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NIP subfamily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" name="Group 10"/>
            <p:cNvGrpSpPr/>
            <p:nvPr/>
          </p:nvGrpSpPr>
          <p:grpSpPr>
            <a:xfrm>
              <a:off x="314812" y="638294"/>
              <a:ext cx="8524389" cy="4543306"/>
              <a:chOff x="314812" y="638294"/>
              <a:chExt cx="8524389" cy="4543306"/>
            </a:xfrm>
          </p:grpSpPr>
          <p:pic>
            <p:nvPicPr>
              <p:cNvPr id="5" name="Picture 4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314812" y="685800"/>
                <a:ext cx="8524389" cy="4495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cxnSp>
            <p:nvCxnSpPr>
              <p:cNvPr id="7" name="Straight Connector 6"/>
              <p:cNvCxnSpPr/>
              <p:nvPr/>
            </p:nvCxnSpPr>
            <p:spPr>
              <a:xfrm>
                <a:off x="3932814" y="814202"/>
                <a:ext cx="4572000" cy="1588"/>
              </a:xfrm>
              <a:prstGeom prst="lin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/>
              <p:cNvCxnSpPr/>
              <p:nvPr/>
            </p:nvCxnSpPr>
            <p:spPr>
              <a:xfrm>
                <a:off x="807645" y="3100196"/>
                <a:ext cx="4937760" cy="1588"/>
              </a:xfrm>
              <a:prstGeom prst="lin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Rectangle 8"/>
              <p:cNvSpPr/>
              <p:nvPr/>
            </p:nvSpPr>
            <p:spPr>
              <a:xfrm>
                <a:off x="2209800" y="2924294"/>
                <a:ext cx="768544" cy="184666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200" dirty="0" smtClean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MIP domain</a:t>
                </a:r>
                <a:endParaRPr lang="en-US" sz="1200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" name="Rectangle 9"/>
              <p:cNvSpPr/>
              <p:nvPr/>
            </p:nvSpPr>
            <p:spPr>
              <a:xfrm>
                <a:off x="6622856" y="638294"/>
                <a:ext cx="768544" cy="184666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200" dirty="0" smtClean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MIP domain</a:t>
                </a:r>
                <a:endParaRPr lang="en-US" sz="1200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1"/>
          <p:cNvSpPr>
            <a:spLocks noChangeArrowheads="1"/>
          </p:cNvSpPr>
          <p:nvPr/>
        </p:nvSpPr>
        <p:spPr bwMode="auto">
          <a:xfrm>
            <a:off x="6324600" y="4191000"/>
            <a:ext cx="2102066" cy="2769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25" tIns="45713" rIns="91425" bIns="45713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914256" fontAlgn="base"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ure S1b</a:t>
            </a:r>
            <a:endParaRPr lang="en-US" altLang="ja-JP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685800" y="1247002"/>
            <a:ext cx="7848600" cy="2722048"/>
            <a:chOff x="685800" y="1247002"/>
            <a:chExt cx="7848600" cy="2722048"/>
          </a:xfrm>
        </p:grpSpPr>
        <p:sp>
          <p:nvSpPr>
            <p:cNvPr id="4" name="TextBox 3"/>
            <p:cNvSpPr txBox="1"/>
            <p:nvPr/>
          </p:nvSpPr>
          <p:spPr>
            <a:xfrm>
              <a:off x="1219200" y="1247002"/>
              <a:ext cx="1524000" cy="276985"/>
            </a:xfrm>
            <a:prstGeom prst="rect">
              <a:avLst/>
            </a:prstGeom>
            <a:noFill/>
          </p:spPr>
          <p:txBody>
            <a:bodyPr wrap="square" lIns="91425" tIns="45713" rIns="91425" bIns="45713" rtlCol="0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SIP subfamily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" name="Group 10"/>
            <p:cNvGrpSpPr/>
            <p:nvPr/>
          </p:nvGrpSpPr>
          <p:grpSpPr>
            <a:xfrm>
              <a:off x="685800" y="1505925"/>
              <a:ext cx="7848600" cy="2463125"/>
              <a:chOff x="685800" y="1505925"/>
              <a:chExt cx="7848600" cy="2463125"/>
            </a:xfrm>
          </p:grpSpPr>
          <p:pic>
            <p:nvPicPr>
              <p:cNvPr id="37890" name="Picture 2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685800" y="1600200"/>
                <a:ext cx="7848600" cy="236885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cxnSp>
            <p:nvCxnSpPr>
              <p:cNvPr id="7" name="Straight Connector 6"/>
              <p:cNvCxnSpPr/>
              <p:nvPr/>
            </p:nvCxnSpPr>
            <p:spPr>
              <a:xfrm>
                <a:off x="1371600" y="1710462"/>
                <a:ext cx="7010400" cy="1588"/>
              </a:xfrm>
              <a:prstGeom prst="lin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/>
              <p:cNvCxnSpPr/>
              <p:nvPr/>
            </p:nvCxnSpPr>
            <p:spPr>
              <a:xfrm>
                <a:off x="1269291" y="2990951"/>
                <a:ext cx="4937760" cy="1588"/>
              </a:xfrm>
              <a:prstGeom prst="lin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TextBox 8"/>
              <p:cNvSpPr txBox="1"/>
              <p:nvPr/>
            </p:nvSpPr>
            <p:spPr>
              <a:xfrm>
                <a:off x="4953000" y="1505925"/>
                <a:ext cx="1066800" cy="184666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MIP domain</a:t>
                </a:r>
                <a:endParaRPr lang="en-US" sz="1200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2106678" y="2792954"/>
                <a:ext cx="1066800" cy="184666"/>
              </a:xfrm>
              <a:prstGeom prst="rect">
                <a:avLst/>
              </a:prstGeom>
              <a:noFill/>
              <a:ln>
                <a:solidFill>
                  <a:schemeClr val="bg1"/>
                </a:solidFill>
              </a:ln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MIP domain</a:t>
                </a:r>
                <a:endParaRPr lang="en-US" sz="1200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Rectangle 5"/>
          <p:cNvSpPr/>
          <p:nvPr/>
        </p:nvSpPr>
        <p:spPr>
          <a:xfrm>
            <a:off x="6934200" y="6590395"/>
            <a:ext cx="1676400" cy="246207"/>
          </a:xfrm>
          <a:prstGeom prst="rect">
            <a:avLst/>
          </a:prstGeom>
        </p:spPr>
        <p:txBody>
          <a:bodyPr wrap="square" lIns="91425" tIns="45713" rIns="91425" bIns="45713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000" b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ure S1c</a:t>
            </a:r>
            <a:endParaRPr lang="en-US" altLang="ja-JP" sz="1000" dirty="0" smtClean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533400" y="163271"/>
            <a:ext cx="8153400" cy="6466130"/>
            <a:chOff x="533400" y="163271"/>
            <a:chExt cx="8153400" cy="6466130"/>
          </a:xfrm>
        </p:grpSpPr>
        <p:sp>
          <p:nvSpPr>
            <p:cNvPr id="4" name="TextBox 3"/>
            <p:cNvSpPr txBox="1"/>
            <p:nvPr/>
          </p:nvSpPr>
          <p:spPr>
            <a:xfrm>
              <a:off x="990600" y="163271"/>
              <a:ext cx="1524000" cy="276985"/>
            </a:xfrm>
            <a:prstGeom prst="rect">
              <a:avLst/>
            </a:prstGeom>
            <a:noFill/>
          </p:spPr>
          <p:txBody>
            <a:bodyPr wrap="square" lIns="91425" tIns="45713" rIns="91425" bIns="45713" rtlCol="0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PIP subfamily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" name="Group 10"/>
            <p:cNvGrpSpPr/>
            <p:nvPr/>
          </p:nvGrpSpPr>
          <p:grpSpPr>
            <a:xfrm>
              <a:off x="533400" y="291354"/>
              <a:ext cx="8153400" cy="6338047"/>
              <a:chOff x="533400" y="291354"/>
              <a:chExt cx="8153400" cy="6338047"/>
            </a:xfrm>
          </p:grpSpPr>
          <p:pic>
            <p:nvPicPr>
              <p:cNvPr id="5" name="Picture 3"/>
              <p:cNvPicPr>
                <a:picLocks noChangeAspect="1" noChangeArrowheads="1"/>
              </p:cNvPicPr>
              <p:nvPr/>
            </p:nvPicPr>
            <p:blipFill>
              <a:blip r:embed="rId3"/>
              <a:srcRect/>
              <a:stretch>
                <a:fillRect/>
              </a:stretch>
            </p:blipFill>
            <p:spPr bwMode="auto">
              <a:xfrm>
                <a:off x="533400" y="398716"/>
                <a:ext cx="8153400" cy="623068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cxnSp>
            <p:nvCxnSpPr>
              <p:cNvPr id="7" name="Straight Connector 6"/>
              <p:cNvCxnSpPr/>
              <p:nvPr/>
            </p:nvCxnSpPr>
            <p:spPr>
              <a:xfrm>
                <a:off x="1175169" y="3620144"/>
                <a:ext cx="5486400" cy="1588"/>
              </a:xfrm>
              <a:prstGeom prst="lin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" name="Straight Connector 7"/>
              <p:cNvCxnSpPr/>
              <p:nvPr/>
            </p:nvCxnSpPr>
            <p:spPr>
              <a:xfrm>
                <a:off x="3222780" y="484086"/>
                <a:ext cx="5394960" cy="1588"/>
              </a:xfrm>
              <a:prstGeom prst="lin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TextBox 8"/>
              <p:cNvSpPr txBox="1"/>
              <p:nvPr/>
            </p:nvSpPr>
            <p:spPr>
              <a:xfrm>
                <a:off x="2868696" y="3441554"/>
                <a:ext cx="1066800" cy="18466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MIP domain</a:t>
                </a:r>
                <a:endParaRPr lang="en-US" sz="1200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4417383" y="291354"/>
                <a:ext cx="1066800" cy="184666"/>
              </a:xfrm>
              <a:prstGeom prst="rect">
                <a:avLst/>
              </a:prstGeom>
              <a:noFill/>
            </p:spPr>
            <p:txBody>
              <a:bodyPr wrap="square" lIns="0" tIns="0" rIns="0" bIns="0" rtlCol="0">
                <a:spAutoFit/>
              </a:bodyPr>
              <a:lstStyle/>
              <a:p>
                <a:r>
                  <a:rPr lang="en-US" sz="1200" dirty="0" smtClean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MIP domain</a:t>
                </a:r>
                <a:endParaRPr lang="en-US" sz="1200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69" name="Rectangle 1"/>
          <p:cNvSpPr>
            <a:spLocks noChangeArrowheads="1"/>
          </p:cNvSpPr>
          <p:nvPr/>
        </p:nvSpPr>
        <p:spPr bwMode="auto">
          <a:xfrm>
            <a:off x="1" y="5814061"/>
            <a:ext cx="9122532" cy="101564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none" lIns="91425" tIns="45713" rIns="91425" bIns="45713" numCol="1" anchor="ctr" anchorCtr="0" compatLnSpc="1">
            <a:prstTxWarp prst="textNoShape">
              <a:avLst/>
            </a:prstTxWarp>
            <a:spAutoFit/>
          </a:bodyPr>
          <a:lstStyle/>
          <a:p>
            <a:pPr algn="just" defTabSz="914256" fontAlgn="base">
              <a:spcBef>
                <a:spcPct val="0"/>
              </a:spcBef>
              <a:spcAft>
                <a:spcPct val="0"/>
              </a:spcAft>
            </a:pPr>
            <a:r>
              <a:rPr lang="en-US" sz="1200" b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igure S1</a:t>
            </a: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 defTabSz="9142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lignment of AA sequences of </a:t>
            </a:r>
            <a:r>
              <a:rPr lang="en-US" sz="1200" i="1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rabidopsis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(1a)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rNIP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1b)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rSIP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(1c)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rPIP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(1d)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BrTIP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ubfamily members. Upper red line indicate </a:t>
            </a:r>
          </a:p>
          <a:p>
            <a:pPr algn="just" defTabSz="9142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predicted 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MIP  domain and blue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lour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portion of the alignment indicate predicted transmembrane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domains.The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two conserved NPA motifs are</a:t>
            </a:r>
          </a:p>
          <a:p>
            <a:pPr algn="just" defTabSz="9142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shown in bold letters pink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lour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. Residues comprising the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ar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/R filter are marked by yellow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colour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and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labelled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H2, H5, LE1 and LE2. Residues</a:t>
            </a:r>
          </a:p>
          <a:p>
            <a:pPr algn="just" defTabSz="914256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occupying conserved </a:t>
            </a:r>
            <a:r>
              <a:rPr lang="en-US" sz="1200" dirty="0" err="1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Froger’s</a:t>
            </a:r>
            <a:r>
              <a:rPr lang="en-US" sz="1200" dirty="0" smtClean="0">
                <a:latin typeface="Times New Roman" pitchFamily="18" charset="0"/>
                <a:ea typeface="Calibri" pitchFamily="34" charset="0"/>
                <a:cs typeface="Times New Roman" pitchFamily="18" charset="0"/>
              </a:rPr>
              <a:t> positions one to five (from N- to C-terminus P1 to P5) are marked in green letters. </a:t>
            </a: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6977736" y="5814061"/>
            <a:ext cx="1676400" cy="246207"/>
          </a:xfrm>
          <a:prstGeom prst="rect">
            <a:avLst/>
          </a:prstGeom>
        </p:spPr>
        <p:txBody>
          <a:bodyPr wrap="square" lIns="91425" tIns="45713" rIns="91425" bIns="45713">
            <a:spAutoFit/>
          </a:bodyPr>
          <a:lstStyle/>
          <a:p>
            <a:pPr lvl="0" algn="just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ja-JP" sz="1000" b="1" dirty="0" smtClean="0">
                <a:solidFill>
                  <a:srgbClr val="000000"/>
                </a:solidFill>
                <a:latin typeface="Times New Roman" pitchFamily="18" charset="0"/>
                <a:ea typeface="Times New Roman" pitchFamily="18" charset="0"/>
                <a:cs typeface="Times New Roman" pitchFamily="18" charset="0"/>
              </a:rPr>
              <a:t>Figure S1d</a:t>
            </a:r>
            <a:endParaRPr lang="en-US" altLang="ja-JP" sz="1000" dirty="0" smtClean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12" name="Group 11"/>
          <p:cNvGrpSpPr/>
          <p:nvPr/>
        </p:nvGrpSpPr>
        <p:grpSpPr>
          <a:xfrm>
            <a:off x="381000" y="-74022"/>
            <a:ext cx="8229600" cy="5905728"/>
            <a:chOff x="381000" y="-74022"/>
            <a:chExt cx="8229600" cy="5905728"/>
          </a:xfrm>
        </p:grpSpPr>
        <p:sp>
          <p:nvSpPr>
            <p:cNvPr id="7" name="TextBox 6"/>
            <p:cNvSpPr txBox="1"/>
            <p:nvPr/>
          </p:nvSpPr>
          <p:spPr>
            <a:xfrm>
              <a:off x="466725" y="-74022"/>
              <a:ext cx="1524000" cy="276985"/>
            </a:xfrm>
            <a:prstGeom prst="rect">
              <a:avLst/>
            </a:prstGeom>
            <a:noFill/>
          </p:spPr>
          <p:txBody>
            <a:bodyPr wrap="square" lIns="91425" tIns="45713" rIns="91425" bIns="45713" rtlCol="0">
              <a:spAutoFit/>
            </a:bodyPr>
            <a:lstStyle/>
            <a:p>
              <a:r>
                <a:rPr lang="en-US" sz="1200" dirty="0" smtClean="0">
                  <a:latin typeface="Times New Roman" pitchFamily="18" charset="0"/>
                  <a:cs typeface="Times New Roman" pitchFamily="18" charset="0"/>
                </a:rPr>
                <a:t>TIP subfamily</a:t>
              </a:r>
              <a:endParaRPr 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2" name="Group 11"/>
            <p:cNvGrpSpPr/>
            <p:nvPr/>
          </p:nvGrpSpPr>
          <p:grpSpPr>
            <a:xfrm>
              <a:off x="381000" y="63530"/>
              <a:ext cx="8229600" cy="5768176"/>
              <a:chOff x="381000" y="-1786"/>
              <a:chExt cx="8229600" cy="5768176"/>
            </a:xfrm>
          </p:grpSpPr>
          <p:pic>
            <p:nvPicPr>
              <p:cNvPr id="5" name="Picture 3"/>
              <p:cNvPicPr>
                <a:picLocks noChangeAspect="1" noChangeArrowheads="1"/>
              </p:cNvPicPr>
              <p:nvPr/>
            </p:nvPicPr>
            <p:blipFill>
              <a:blip r:embed="rId2"/>
              <a:srcRect/>
              <a:stretch>
                <a:fillRect/>
              </a:stretch>
            </p:blipFill>
            <p:spPr bwMode="auto">
              <a:xfrm>
                <a:off x="381000" y="87083"/>
                <a:ext cx="8229600" cy="5679307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8" name="Rectangle 7"/>
              <p:cNvSpPr/>
              <p:nvPr/>
            </p:nvSpPr>
            <p:spPr>
              <a:xfrm>
                <a:off x="5517956" y="-1786"/>
                <a:ext cx="768544" cy="184666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200" dirty="0" smtClean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MIP domain</a:t>
                </a:r>
                <a:endParaRPr lang="en-US" sz="1200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cxnSp>
            <p:nvCxnSpPr>
              <p:cNvPr id="9" name="Straight Connector 8"/>
              <p:cNvCxnSpPr/>
              <p:nvPr/>
            </p:nvCxnSpPr>
            <p:spPr>
              <a:xfrm>
                <a:off x="1790700" y="175260"/>
                <a:ext cx="6675120" cy="1588"/>
              </a:xfrm>
              <a:prstGeom prst="lin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" name="Straight Connector 9"/>
              <p:cNvCxnSpPr/>
              <p:nvPr/>
            </p:nvCxnSpPr>
            <p:spPr>
              <a:xfrm>
                <a:off x="1013460" y="3040380"/>
                <a:ext cx="4754880" cy="1588"/>
              </a:xfrm>
              <a:prstGeom prst="line">
                <a:avLst/>
              </a:prstGeom>
              <a:ln w="158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" name="Rectangle 10"/>
              <p:cNvSpPr/>
              <p:nvPr/>
            </p:nvSpPr>
            <p:spPr>
              <a:xfrm>
                <a:off x="1981200" y="2863334"/>
                <a:ext cx="768544" cy="184666"/>
              </a:xfrm>
              <a:prstGeom prst="rect">
                <a:avLst/>
              </a:prstGeom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sz="1200" dirty="0" smtClean="0">
                    <a:solidFill>
                      <a:srgbClr val="FF0000"/>
                    </a:solidFill>
                    <a:latin typeface="Times New Roman" pitchFamily="18" charset="0"/>
                    <a:cs typeface="Times New Roman" pitchFamily="18" charset="0"/>
                  </a:rPr>
                  <a:t>MIP domain</a:t>
                </a:r>
                <a:endParaRPr lang="en-US" sz="1200" dirty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37</Words>
  <Application>Microsoft Office PowerPoint</Application>
  <PresentationFormat>On-screen Show (4:3)</PresentationFormat>
  <Paragraphs>22</Paragraphs>
  <Slides>4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5" baseType="lpstr"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KAYUM</dc:creator>
  <cp:lastModifiedBy>Balindan, Danica Joy</cp:lastModifiedBy>
  <cp:revision>9</cp:revision>
  <dcterms:created xsi:type="dcterms:W3CDTF">2016-12-21T05:42:39Z</dcterms:created>
  <dcterms:modified xsi:type="dcterms:W3CDTF">2017-01-20T01:35:29Z</dcterms:modified>
</cp:coreProperties>
</file>